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2" d="100"/>
          <a:sy n="42" d="100"/>
        </p:scale>
        <p:origin x="1805" y="9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54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4375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2858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2215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308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473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891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0372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312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9770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843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746DF-841D-43DE-81E5-F3043E8DE0C0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F3EE0-6B29-4C84-944D-3D4A139D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896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96583" y="2405565"/>
            <a:ext cx="5940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LF1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715" y="665164"/>
            <a:ext cx="5400000" cy="240832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715" y="3113345"/>
            <a:ext cx="5400000" cy="229709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230285" y="3439314"/>
            <a:ext cx="338554" cy="16451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Axon guidance</a:t>
            </a:r>
            <a:endParaRPr lang="en-GB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1772816" y="4261890"/>
            <a:ext cx="492443" cy="8225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Generation of neurons</a:t>
            </a:r>
            <a:endParaRPr lang="en-GB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2344494" y="4139952"/>
            <a:ext cx="492443" cy="94451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Regulation of neurogenesis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50022" y="6300191"/>
            <a:ext cx="338554" cy="197441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Chromosome Z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6673" y="467544"/>
            <a:ext cx="376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76673" y="3077804"/>
            <a:ext cx="753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1916" y="1187625"/>
            <a:ext cx="338554" cy="146416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Metabolic process</a:t>
            </a:r>
            <a:endParaRPr lang="en-GB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1849760" y="1187626"/>
            <a:ext cx="338554" cy="146416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Lipid binding</a:t>
            </a:r>
            <a:endParaRPr lang="en-GB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2420888" y="1619672"/>
            <a:ext cx="492443" cy="103211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Lipid biosynthetic process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3095493" y="1704457"/>
            <a:ext cx="492443" cy="98931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Nucleotide binding</a:t>
            </a:r>
            <a:endParaRPr lang="en-GB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3604637" y="1739414"/>
            <a:ext cx="646331" cy="98931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Alcohol metabolic process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4365104" y="1879834"/>
            <a:ext cx="492443" cy="85446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Biosynthetic process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50022" y="251520"/>
            <a:ext cx="2391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02348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36" y="899592"/>
            <a:ext cx="6480000" cy="192439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36" y="3419872"/>
            <a:ext cx="6480000" cy="191235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36" y="5724128"/>
            <a:ext cx="2880000" cy="30206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7416" y="5395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77416" y="533223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77416" y="314287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8674" y="7092280"/>
            <a:ext cx="369332" cy="108941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ELF1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58042" y="7524329"/>
            <a:ext cx="369332" cy="6573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200" dirty="0" smtClean="0"/>
              <a:t>ETV4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20402" y="4126381"/>
            <a:ext cx="1030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as transport</a:t>
            </a:r>
            <a:endParaRPr lang="en-GB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1069618" y="4318727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Muscle contraction</a:t>
            </a:r>
            <a:endParaRPr lang="en-GB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2010104" y="4441838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Hydrolase activity</a:t>
            </a:r>
            <a:endParaRPr lang="en-GB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2852936" y="4682853"/>
            <a:ext cx="16482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Cytoskeletal protein binding</a:t>
            </a:r>
            <a:endParaRPr lang="en-GB" sz="10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709464" y="4372602"/>
            <a:ext cx="0" cy="19234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412776" y="4564948"/>
            <a:ext cx="0" cy="12311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12" idx="1"/>
          </p:cNvCxnSpPr>
          <p:nvPr/>
        </p:nvCxnSpPr>
        <p:spPr>
          <a:xfrm flipH="1">
            <a:off x="1916832" y="4564949"/>
            <a:ext cx="93272" cy="11790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13" idx="1"/>
          </p:cNvCxnSpPr>
          <p:nvPr/>
        </p:nvCxnSpPr>
        <p:spPr>
          <a:xfrm flipH="1">
            <a:off x="2696411" y="4805964"/>
            <a:ext cx="156525" cy="12311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90701" y="810854"/>
            <a:ext cx="957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rotein binding</a:t>
            </a:r>
            <a:endParaRPr lang="en-GB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1098895" y="1157482"/>
            <a:ext cx="13681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Immune system processes</a:t>
            </a:r>
            <a:endParaRPr lang="en-GB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1290254" y="1379078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Signal transduction</a:t>
            </a:r>
            <a:endParaRPr lang="en-GB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1762294" y="1594522"/>
            <a:ext cx="12161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Leukocyte activation</a:t>
            </a:r>
            <a:endParaRPr lang="en-GB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4005064" y="1861787"/>
            <a:ext cx="1188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ytokine binding</a:t>
            </a:r>
            <a:endParaRPr lang="en-GB" sz="800" dirty="0"/>
          </a:p>
        </p:txBody>
      </p:sp>
      <p:cxnSp>
        <p:nvCxnSpPr>
          <p:cNvPr id="24" name="Straight Arrow Connector 23"/>
          <p:cNvCxnSpPr/>
          <p:nvPr/>
        </p:nvCxnSpPr>
        <p:spPr>
          <a:xfrm flipH="1">
            <a:off x="4005064" y="1969509"/>
            <a:ext cx="72008" cy="15421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stCxn id="20" idx="1"/>
          </p:cNvCxnSpPr>
          <p:nvPr/>
        </p:nvCxnSpPr>
        <p:spPr>
          <a:xfrm flipH="1">
            <a:off x="1606936" y="1702244"/>
            <a:ext cx="155358" cy="15954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H="1">
            <a:off x="934091" y="1486800"/>
            <a:ext cx="293283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stCxn id="16" idx="1"/>
          </p:cNvCxnSpPr>
          <p:nvPr/>
        </p:nvCxnSpPr>
        <p:spPr>
          <a:xfrm flipH="1">
            <a:off x="858042" y="1265204"/>
            <a:ext cx="240853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flipH="1">
            <a:off x="709464" y="899592"/>
            <a:ext cx="224627" cy="25789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4861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0</Words>
  <Application>Microsoft Office PowerPoint</Application>
  <PresentationFormat>On-screen Show (4:3)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 Jacqueline</dc:creator>
  <cp:lastModifiedBy>David Burt</cp:lastModifiedBy>
  <cp:revision>19</cp:revision>
  <dcterms:created xsi:type="dcterms:W3CDTF">2013-08-28T12:44:56Z</dcterms:created>
  <dcterms:modified xsi:type="dcterms:W3CDTF">2014-08-15T16:00:40Z</dcterms:modified>
</cp:coreProperties>
</file>